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6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3" d="100"/>
          <a:sy n="83" d="100"/>
        </p:scale>
        <p:origin x="686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36AEBA-5978-45CF-BA49-8B0585F7291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31160C3-1AA6-4663-8AAF-179505E2BFC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5AA8AE5-7A09-4D5D-9F76-3BF737783D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D075F-C3F6-42FB-A37C-5BFD0869C459}" type="datetimeFigureOut">
              <a:rPr lang="en-US" smtClean="0"/>
              <a:t>11/23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5852BAB-F8A0-4B52-81CC-788133FBF7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61A0927-C4BB-4061-8644-45D94CD5D0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0BF935-C218-48F4-B7B4-18F8EE5BE3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72621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1E753B1-4BC6-4BCC-9095-CCD78E6A42E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B9EF63E-1EE3-48F4-AD7B-A9FE2D0943B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87F4C1D-101B-4970-A4FD-75E41949F9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D075F-C3F6-42FB-A37C-5BFD0869C459}" type="datetimeFigureOut">
              <a:rPr lang="en-US" smtClean="0"/>
              <a:t>11/23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CA1E037-30D6-4F50-BADF-582D78613D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B4B861C-4F10-4393-95BC-E370E006CC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0BF935-C218-48F4-B7B4-18F8EE5BE3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18849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67A3D16-4FFC-4B4A-BD8A-9E6CB23BA0E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9EB7C0F-E322-4DF2-B7BA-B306D5DA0EF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41848CE-3369-412C-BC80-F10842F228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D075F-C3F6-42FB-A37C-5BFD0869C459}" type="datetimeFigureOut">
              <a:rPr lang="en-US" smtClean="0"/>
              <a:t>11/23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A24CE92-D18C-4C04-9BB7-46295CBC0E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4C315C5-77AB-49FE-B5E7-039FFFB49D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0BF935-C218-48F4-B7B4-18F8EE5BE3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98439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5CC52A-1AB6-499F-B610-B111FAF8C6C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294E296-C80C-4609-9436-DD7F752D803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6959783-F752-4D56-9172-96E0966F97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D075F-C3F6-42FB-A37C-5BFD0869C459}" type="datetimeFigureOut">
              <a:rPr lang="en-US" smtClean="0"/>
              <a:t>11/23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F250B7F-0AD1-4A3E-90D1-82BCDA9154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C7D52F3-A643-4AEE-B75F-3F96CE4D76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0BF935-C218-48F4-B7B4-18F8EE5BE3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5723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BB041C-FF36-402D-9270-247F4BC9496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C39D97C-D4DF-4AFD-ABC7-5FD97A3E772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7432695-5EF4-49B5-B7EA-6FD9F8DB93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D075F-C3F6-42FB-A37C-5BFD0869C459}" type="datetimeFigureOut">
              <a:rPr lang="en-US" smtClean="0"/>
              <a:t>11/23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C6F8BA5-F813-41EC-9FF9-EBCABFBC72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58B4D7D-A8FC-4E69-AD87-213AB289D2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0BF935-C218-48F4-B7B4-18F8EE5BE3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94248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799E105-AC74-45CA-8CBA-1A3D400C6D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007026D-B186-4B08-BCCA-934B6C4E84D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105FD04-670B-4F73-B2C9-5A67596B4B1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E8BA50B-D8A4-4AED-9AC6-B80A09583F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D075F-C3F6-42FB-A37C-5BFD0869C459}" type="datetimeFigureOut">
              <a:rPr lang="en-US" smtClean="0"/>
              <a:t>11/23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35645CD-F118-48FB-8831-374E570CB1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F0D7803-622E-4E6E-A657-3B9B13F5C4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0BF935-C218-48F4-B7B4-18F8EE5BE3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12670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6100F07-0681-4615-B9CB-0EAE57DDC8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9308E00-9C10-4480-BE87-A32C16A4812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46627B2-20C3-4100-92AD-7C2E6EB27AA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9E83AAE-347B-4B4C-9FDB-C2B0A543F71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68730C3-9241-4CD7-AB80-F3D7BA5D83B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91548BD-F5CC-4C63-8111-881CBD97F9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D075F-C3F6-42FB-A37C-5BFD0869C459}" type="datetimeFigureOut">
              <a:rPr lang="en-US" smtClean="0"/>
              <a:t>11/23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A57C349-42CC-4754-BCB6-58EE1DAD07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03126F6-8273-4A04-853E-5DB5EB6611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0BF935-C218-48F4-B7B4-18F8EE5BE3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48955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A2E7D0-2418-4939-9C7D-71750AC6F1B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B00EF99-445A-417A-A14E-72D10B535D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D075F-C3F6-42FB-A37C-5BFD0869C459}" type="datetimeFigureOut">
              <a:rPr lang="en-US" smtClean="0"/>
              <a:t>11/23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94469B3-9607-493B-8D19-CEAF53D423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81741C5-0FA8-4BB8-BE4F-38F8CE0627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0BF935-C218-48F4-B7B4-18F8EE5BE3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355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6E23232-9020-4322-AC17-5258B775A9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D075F-C3F6-42FB-A37C-5BFD0869C459}" type="datetimeFigureOut">
              <a:rPr lang="en-US" smtClean="0"/>
              <a:t>11/23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A94DE47-832B-4E59-B622-0E3EBC756E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6A78C61-B4BA-491E-BAFB-0B43DBB5FD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0BF935-C218-48F4-B7B4-18F8EE5BE3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82552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80D7B0-761D-45E4-B70B-4F8C19E2BE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482C5A0-E454-4F89-BB4A-90091346062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D01170E-A806-4D23-B4BB-6548833969E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99F77A5-5D96-4C56-AE39-F0729C5C58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D075F-C3F6-42FB-A37C-5BFD0869C459}" type="datetimeFigureOut">
              <a:rPr lang="en-US" smtClean="0"/>
              <a:t>11/23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7C2A503-6546-4A52-AFAC-9C9D7AC8D5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9F29617-3049-40C2-AFCD-9C7EC93CE3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0BF935-C218-48F4-B7B4-18F8EE5BE3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86032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F483CA-B4C9-4F9C-8121-A66BFF8193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73985DC-5821-4599-974E-886CA44AE77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5B01946-06D1-454F-99F3-0384D569EA6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4F6A016-43C2-42B6-BC33-13EC15421B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D075F-C3F6-42FB-A37C-5BFD0869C459}" type="datetimeFigureOut">
              <a:rPr lang="en-US" smtClean="0"/>
              <a:t>11/23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DE4ED6C-FB2B-43C9-87BE-81EC2442C3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99D0BDA-10A2-4D51-B021-C59D9812C7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0BF935-C218-48F4-B7B4-18F8EE5BE3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40934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17F60E8-C0D5-484F-9F0D-5566CB1A247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DD5B6C9-FD50-46FF-8DD9-2568226B9D0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6A15C21-DB13-4785-96FE-0594F24C37D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CD075F-C3F6-42FB-A37C-5BFD0869C459}" type="datetimeFigureOut">
              <a:rPr lang="en-US" smtClean="0"/>
              <a:t>11/23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6180180-5B8A-4DB3-9AEF-8506FB4895F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DDD6D0C-9E54-43EF-9317-66647737AE6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0BF935-C218-48F4-B7B4-18F8EE5BE3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2887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jpe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" name="Immagine 4">
            <a:extLst>
              <a:ext uri="{FF2B5EF4-FFF2-40B4-BE49-F238E27FC236}">
                <a16:creationId xmlns:a16="http://schemas.microsoft.com/office/drawing/2014/main" id="{F5421105-63DB-4CE6-A617-24AD8DFBAAFA}"/>
              </a:ext>
            </a:extLst>
          </p:cNvPr>
          <p:cNvPicPr/>
          <p:nvPr/>
        </p:nvPicPr>
        <p:blipFill rotWithShape="1">
          <a:blip r:embed="rId2"/>
          <a:srcRect l="65002" t="4117" r="14245" b="65488"/>
          <a:stretch/>
        </p:blipFill>
        <p:spPr>
          <a:xfrm>
            <a:off x="3052927" y="102952"/>
            <a:ext cx="2953955" cy="2862190"/>
          </a:xfrm>
          <a:prstGeom prst="rect">
            <a:avLst/>
          </a:prstGeom>
        </p:spPr>
      </p:pic>
      <p:pic>
        <p:nvPicPr>
          <p:cNvPr id="23" name="Immagine 4">
            <a:extLst>
              <a:ext uri="{FF2B5EF4-FFF2-40B4-BE49-F238E27FC236}">
                <a16:creationId xmlns:a16="http://schemas.microsoft.com/office/drawing/2014/main" id="{83A59134-C4F4-4C70-B322-D02C9E97A238}"/>
              </a:ext>
            </a:extLst>
          </p:cNvPr>
          <p:cNvPicPr/>
          <p:nvPr/>
        </p:nvPicPr>
        <p:blipFill rotWithShape="1">
          <a:blip r:embed="rId2"/>
          <a:srcRect l="11663" t="62593" r="64402" b="2779"/>
          <a:stretch/>
        </p:blipFill>
        <p:spPr>
          <a:xfrm>
            <a:off x="14431" y="102952"/>
            <a:ext cx="3040068" cy="2862190"/>
          </a:xfrm>
          <a:prstGeom prst="rect">
            <a:avLst/>
          </a:prstGeom>
        </p:spPr>
      </p:pic>
      <p:pic>
        <p:nvPicPr>
          <p:cNvPr id="4" name="Immagine 6">
            <a:extLst>
              <a:ext uri="{FF2B5EF4-FFF2-40B4-BE49-F238E27FC236}">
                <a16:creationId xmlns:a16="http://schemas.microsoft.com/office/drawing/2014/main" id="{4B3B1BE2-A35B-4895-B039-5760854CB7F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06885" y="102952"/>
            <a:ext cx="6080133" cy="2862190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893039B3-A5BE-42BF-AE90-5D8C5985DD18}"/>
              </a:ext>
            </a:extLst>
          </p:cNvPr>
          <p:cNvSpPr txBox="1"/>
          <p:nvPr/>
        </p:nvSpPr>
        <p:spPr>
          <a:xfrm>
            <a:off x="102644" y="102952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6CAC69B0-CE3C-47E1-A094-7EF7C7770AEF}"/>
              </a:ext>
            </a:extLst>
          </p:cNvPr>
          <p:cNvSpPr txBox="1"/>
          <p:nvPr/>
        </p:nvSpPr>
        <p:spPr>
          <a:xfrm>
            <a:off x="3054764" y="102952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DD673957-3906-4134-9F9B-E78F7EF4F290}"/>
              </a:ext>
            </a:extLst>
          </p:cNvPr>
          <p:cNvSpPr txBox="1"/>
          <p:nvPr/>
        </p:nvSpPr>
        <p:spPr>
          <a:xfrm>
            <a:off x="6006884" y="102952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C601CB85-C724-4132-BECA-3FAD1B1DFAC2}"/>
              </a:ext>
            </a:extLst>
          </p:cNvPr>
          <p:cNvSpPr txBox="1"/>
          <p:nvPr/>
        </p:nvSpPr>
        <p:spPr>
          <a:xfrm>
            <a:off x="9046951" y="102952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</a:t>
            </a:r>
          </a:p>
        </p:txBody>
      </p:sp>
      <p:grpSp>
        <p:nvGrpSpPr>
          <p:cNvPr id="21" name="Group 20">
            <a:extLst>
              <a:ext uri="{FF2B5EF4-FFF2-40B4-BE49-F238E27FC236}">
                <a16:creationId xmlns:a16="http://schemas.microsoft.com/office/drawing/2014/main" id="{7171F4B2-08C4-4146-8F33-60FB924AA8B9}"/>
              </a:ext>
            </a:extLst>
          </p:cNvPr>
          <p:cNvGrpSpPr/>
          <p:nvPr/>
        </p:nvGrpSpPr>
        <p:grpSpPr>
          <a:xfrm>
            <a:off x="1381029" y="3072641"/>
            <a:ext cx="9429943" cy="2091109"/>
            <a:chOff x="102644" y="3072641"/>
            <a:chExt cx="9429943" cy="2091109"/>
          </a:xfrm>
        </p:grpSpPr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8AB1639E-7220-4D17-B10A-E999321D95F4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02644" y="3073880"/>
              <a:ext cx="2292295" cy="2085013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7D447B86-93EC-4B64-B78B-B600D85AD675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481860" y="3072641"/>
              <a:ext cx="2292295" cy="2091109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E1C15814-3524-48C4-A4C0-7F69658808F3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4861076" y="3072641"/>
              <a:ext cx="2292295" cy="2091109"/>
            </a:xfrm>
            <a:prstGeom prst="rect">
              <a:avLst/>
            </a:prstGeom>
          </p:spPr>
        </p:pic>
        <p:pic>
          <p:nvPicPr>
            <p:cNvPr id="11" name="Picture 10" descr="A picture containing indoor, beverage, plastic, glass&#10;&#10;Description automatically generated">
              <a:extLst>
                <a:ext uri="{FF2B5EF4-FFF2-40B4-BE49-F238E27FC236}">
                  <a16:creationId xmlns:a16="http://schemas.microsoft.com/office/drawing/2014/main" id="{D0813F2A-9EFE-4AF1-9960-A00FF226FF1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846" t="37541" r="27160" b="14563"/>
            <a:stretch/>
          </p:blipFill>
          <p:spPr>
            <a:xfrm>
              <a:off x="7240292" y="3072641"/>
              <a:ext cx="2292295" cy="2086252"/>
            </a:xfrm>
            <a:prstGeom prst="rect">
              <a:avLst/>
            </a:prstGeom>
          </p:spPr>
        </p:pic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FD016F10-FD9D-4572-8B4D-E1403B4E981F}"/>
                </a:ext>
              </a:extLst>
            </p:cNvPr>
            <p:cNvSpPr txBox="1"/>
            <p:nvPr/>
          </p:nvSpPr>
          <p:spPr>
            <a:xfrm>
              <a:off x="110987" y="3072641"/>
              <a:ext cx="29687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E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D5AEEAB5-F930-48D3-97C7-9832DD718B07}"/>
                </a:ext>
              </a:extLst>
            </p:cNvPr>
            <p:cNvSpPr txBox="1"/>
            <p:nvPr/>
          </p:nvSpPr>
          <p:spPr>
            <a:xfrm>
              <a:off x="2481860" y="3072641"/>
              <a:ext cx="29687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F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4A1FEC23-6497-4579-B04E-CE62DBC1FB8A}"/>
                </a:ext>
              </a:extLst>
            </p:cNvPr>
            <p:cNvSpPr txBox="1"/>
            <p:nvPr/>
          </p:nvSpPr>
          <p:spPr>
            <a:xfrm>
              <a:off x="4861076" y="3072641"/>
              <a:ext cx="33054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G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990FB2D1-42FB-444C-8528-CCFAD40A8FE3}"/>
                </a:ext>
              </a:extLst>
            </p:cNvPr>
            <p:cNvSpPr txBox="1"/>
            <p:nvPr/>
          </p:nvSpPr>
          <p:spPr>
            <a:xfrm>
              <a:off x="7240292" y="3072641"/>
              <a:ext cx="33054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H</a:t>
              </a:r>
            </a:p>
          </p:txBody>
        </p:sp>
      </p:grpSp>
      <p:sp>
        <p:nvSpPr>
          <p:cNvPr id="20" name="TextBox 19">
            <a:extLst>
              <a:ext uri="{FF2B5EF4-FFF2-40B4-BE49-F238E27FC236}">
                <a16:creationId xmlns:a16="http://schemas.microsoft.com/office/drawing/2014/main" id="{D7B9B658-010F-40AC-A766-B153AAC843BB}"/>
              </a:ext>
            </a:extLst>
          </p:cNvPr>
          <p:cNvSpPr txBox="1"/>
          <p:nvPr/>
        </p:nvSpPr>
        <p:spPr>
          <a:xfrm>
            <a:off x="1" y="5306739"/>
            <a:ext cx="12087018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S1: </a:t>
            </a:r>
            <a:r>
              <a:rPr lang="en-US" dirty="0"/>
              <a:t>Images showing examples of results obtained during </a:t>
            </a:r>
            <a:r>
              <a:rPr lang="en-US" i="1" dirty="0"/>
              <a:t>in vitro</a:t>
            </a:r>
            <a:r>
              <a:rPr lang="en-US" dirty="0"/>
              <a:t> or </a:t>
            </a:r>
            <a:r>
              <a:rPr lang="en-US" i="1" dirty="0"/>
              <a:t>in vivo</a:t>
            </a:r>
            <a:r>
              <a:rPr lang="en-US" dirty="0"/>
              <a:t> antifungal assays. A) Unsuccessful and B) successful inhibition of </a:t>
            </a:r>
            <a:r>
              <a:rPr lang="en-US" i="1" dirty="0"/>
              <a:t>Fusarium verticillioides</a:t>
            </a:r>
            <a:r>
              <a:rPr lang="en-US" dirty="0"/>
              <a:t> in </a:t>
            </a:r>
            <a:r>
              <a:rPr lang="en-US" i="1" dirty="0"/>
              <a:t>in vitro</a:t>
            </a:r>
            <a:r>
              <a:rPr lang="en-US" dirty="0"/>
              <a:t> qualitative assays; C) Unsuccessful and D) successful inhibition of </a:t>
            </a:r>
            <a:r>
              <a:rPr lang="en-US" i="1" dirty="0"/>
              <a:t>Fusarium verticillioides</a:t>
            </a:r>
            <a:r>
              <a:rPr lang="en-US" dirty="0"/>
              <a:t> in </a:t>
            </a:r>
            <a:r>
              <a:rPr lang="en-US" i="1" dirty="0"/>
              <a:t>in vitro</a:t>
            </a:r>
            <a:r>
              <a:rPr lang="en-US" dirty="0"/>
              <a:t> quantitative assays. Examples of classes detected during the in vivo assays: E) Class 0, no symptoms; F) Class 1, growth of mycelium on the plant tissues but no symptoms; G) Class 2, growth of mycelium on the plant tissues and reduced growth; H) Class 3, death of the plant or no germination and high presence of mycelium</a:t>
            </a:r>
          </a:p>
        </p:txBody>
      </p:sp>
    </p:spTree>
    <p:extLst>
      <p:ext uri="{BB962C8B-B14F-4D97-AF65-F5344CB8AC3E}">
        <p14:creationId xmlns:p14="http://schemas.microsoft.com/office/powerpoint/2010/main" val="119033026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8" presetID="10" presetClass="exit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9" dur="500"/>
                                        <p:tgtEl>
                                          <p:spTgt spid="23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2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0" presetClass="exit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12" dur="500"/>
                                        <p:tgtEl>
                                          <p:spTgt spid="24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13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2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5687B61AC85F5E4E8D40EEC5B1171091" ma:contentTypeVersion="8" ma:contentTypeDescription="Create a new document." ma:contentTypeScope="" ma:versionID="9bfd1891e652b4074e14578e5535e03a">
  <xsd:schema xmlns:xsd="http://www.w3.org/2001/XMLSchema" xmlns:xs="http://www.w3.org/2001/XMLSchema" xmlns:p="http://schemas.microsoft.com/office/2006/metadata/properties" xmlns:ns2="5f217c96-5820-4dc0-803f-6a28aad50dd6" targetNamespace="http://schemas.microsoft.com/office/2006/metadata/properties" ma:root="true" ma:fieldsID="aaa1d3f330f38f830b8a4a89f49b09f2" ns2:_="">
    <xsd:import namespace="5f217c96-5820-4dc0-803f-6a28aad50dd6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2:MediaServiceAutoTags" minOccurs="0"/>
                <xsd:element ref="ns2:MediaServiceOCR" minOccurs="0"/>
                <xsd:element ref="ns2:MediaServiceGenerationTime" minOccurs="0"/>
                <xsd:element ref="ns2:MediaServiceEventHashCode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5f217c96-5820-4dc0-803f-6a28aad50dd6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2" nillable="true" ma:displayName="Tags" ma:internalName="MediaServiceAutoTags" ma:readOnly="true">
      <xsd:simpleType>
        <xsd:restriction base="dms:Text"/>
      </xsd:simpleType>
    </xsd:element>
    <xsd:element name="MediaServiceOCR" ma:index="13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59271A58-02FA-425C-A3D2-635A4A40E1AA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5f217c96-5820-4dc0-803f-6a28aad50dd6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AD07BD23-354F-47E5-8C02-224D0D36E748}">
  <ds:schemaRefs>
    <ds:schemaRef ds:uri="http://schemas.microsoft.com/office/2006/metadata/properties"/>
    <ds:schemaRef ds:uri="http://schemas.microsoft.com/office/infopath/2007/PartnerControls"/>
  </ds:schemaRefs>
</ds:datastoreItem>
</file>

<file path=customXml/itemProps3.xml><?xml version="1.0" encoding="utf-8"?>
<ds:datastoreItem xmlns:ds="http://schemas.openxmlformats.org/officeDocument/2006/customXml" ds:itemID="{17178DBA-52C4-4C03-9FDF-0460EC20B723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351</TotalTime>
  <Words>127</Words>
  <Application>Microsoft Office PowerPoint</Application>
  <PresentationFormat>Widescreen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essandro Passera</dc:creator>
  <cp:lastModifiedBy>Alessandro Passera</cp:lastModifiedBy>
  <cp:revision>4</cp:revision>
  <dcterms:created xsi:type="dcterms:W3CDTF">2021-11-11T09:45:01Z</dcterms:created>
  <dcterms:modified xsi:type="dcterms:W3CDTF">2021-11-23T08:26:4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5687B61AC85F5E4E8D40EEC5B1171091</vt:lpwstr>
  </property>
</Properties>
</file>